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906000" cy="6858000" type="A4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78" autoAdjust="0"/>
    <p:restoredTop sz="94660"/>
  </p:normalViewPr>
  <p:slideViewPr>
    <p:cSldViewPr>
      <p:cViewPr>
        <p:scale>
          <a:sx n="110" d="100"/>
          <a:sy n="110" d="100"/>
        </p:scale>
        <p:origin x="-736" y="18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90665" cy="496968"/>
          </a:xfrm>
          <a:prstGeom prst="rect">
            <a:avLst/>
          </a:prstGeom>
        </p:spPr>
        <p:txBody>
          <a:bodyPr vert="horz" lIns="91303" tIns="45651" rIns="91303" bIns="45651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6867" y="0"/>
            <a:ext cx="2890665" cy="496968"/>
          </a:xfrm>
          <a:prstGeom prst="rect">
            <a:avLst/>
          </a:prstGeom>
        </p:spPr>
        <p:txBody>
          <a:bodyPr vert="horz" lIns="91303" tIns="45651" rIns="91303" bIns="45651" rtlCol="0"/>
          <a:lstStyle>
            <a:lvl1pPr algn="r">
              <a:defRPr sz="1200"/>
            </a:lvl1pPr>
          </a:lstStyle>
          <a:p>
            <a:fld id="{3E922AD3-3235-4A6B-993A-D2C2294C209F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46113" y="744538"/>
            <a:ext cx="537686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03" tIns="45651" rIns="91303" bIns="45651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597" y="4715630"/>
            <a:ext cx="5335894" cy="4467939"/>
          </a:xfrm>
          <a:prstGeom prst="rect">
            <a:avLst/>
          </a:prstGeom>
        </p:spPr>
        <p:txBody>
          <a:bodyPr vert="horz" lIns="91303" tIns="45651" rIns="91303" bIns="4565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671"/>
            <a:ext cx="2890665" cy="496967"/>
          </a:xfrm>
          <a:prstGeom prst="rect">
            <a:avLst/>
          </a:prstGeom>
        </p:spPr>
        <p:txBody>
          <a:bodyPr vert="horz" lIns="91303" tIns="45651" rIns="91303" bIns="45651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6867" y="9429671"/>
            <a:ext cx="2890665" cy="496967"/>
          </a:xfrm>
          <a:prstGeom prst="rect">
            <a:avLst/>
          </a:prstGeom>
        </p:spPr>
        <p:txBody>
          <a:bodyPr vert="horz" lIns="91303" tIns="45651" rIns="91303" bIns="45651" rtlCol="0" anchor="b"/>
          <a:lstStyle>
            <a:lvl1pPr algn="r">
              <a:defRPr sz="1200"/>
            </a:lvl1pPr>
          </a:lstStyle>
          <a:p>
            <a:fld id="{200F5D68-5625-42D0-9004-03F4D20A7D3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12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9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6"/>
            <a:ext cx="8420100" cy="150018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5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5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6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6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5" y="273051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5" y="273054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5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2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40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3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CB87D-D42E-462C-B249-9B7C04A10990}" type="datetimeFigureOut">
              <a:rPr lang="en-GB" smtClean="0"/>
              <a:pPr/>
              <a:t>27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37CED-2CF0-433B-9D18-F5A41AC2EE4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96552" y="1484786"/>
            <a:ext cx="8736969" cy="2945172"/>
            <a:chOff x="620689" y="2144690"/>
            <a:chExt cx="6048671" cy="4254138"/>
          </a:xfrm>
        </p:grpSpPr>
        <p:pic>
          <p:nvPicPr>
            <p:cNvPr id="4" name="Picture 3" descr="220812  MS peak 13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620689" y="3961925"/>
              <a:ext cx="1728192" cy="23549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Right Triangle 4"/>
            <p:cNvSpPr/>
            <p:nvPr/>
          </p:nvSpPr>
          <p:spPr>
            <a:xfrm flipH="1">
              <a:off x="958531" y="3670305"/>
              <a:ext cx="774176" cy="156017"/>
            </a:xfrm>
            <a:prstGeom prst="rtTriangle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12627" y="3358269"/>
              <a:ext cx="773996" cy="4890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 smtClean="0"/>
                <a:t>GlnR</a:t>
              </a:r>
              <a:endParaRPr lang="en-GB" sz="16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38239" y="3505046"/>
              <a:ext cx="356386" cy="7557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b="1" dirty="0" smtClean="0"/>
                <a:t>-</a:t>
              </a:r>
              <a:endParaRPr lang="en-GB" sz="2800" b="1" dirty="0"/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1076119" y="2959992"/>
              <a:ext cx="1638184" cy="3196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Specific cold DNA</a:t>
              </a:r>
              <a:endParaRPr lang="en-GB" sz="1200" b="1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250225" y="2881985"/>
              <a:ext cx="1794204" cy="3196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Non- specific cold DNA</a:t>
              </a:r>
              <a:endParaRPr lang="en-GB" sz="1200" b="1" dirty="0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16203" t="12658" r="1772" b="20253"/>
            <a:stretch>
              <a:fillRect/>
            </a:stretch>
          </p:blipFill>
          <p:spPr bwMode="auto">
            <a:xfrm>
              <a:off x="2492896" y="3279322"/>
              <a:ext cx="4176464" cy="29604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TextBox 10"/>
            <p:cNvSpPr txBox="1"/>
            <p:nvPr/>
          </p:nvSpPr>
          <p:spPr>
            <a:xfrm>
              <a:off x="2396955" y="3975620"/>
              <a:ext cx="792088" cy="311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/>
                <a:t>input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396506" y="4425961"/>
              <a:ext cx="792088" cy="311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/>
                <a:t>exces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04906" y="5054269"/>
              <a:ext cx="792088" cy="311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/>
                <a:t>limiting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04906" y="5429970"/>
              <a:ext cx="792088" cy="4890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 smtClean="0"/>
                <a:t>gene</a:t>
              </a:r>
            </a:p>
            <a:p>
              <a:pPr algn="ctr"/>
              <a:r>
                <a:rPr lang="en-GB" sz="800" b="1" dirty="0" smtClean="0"/>
                <a:t>expression</a:t>
              </a: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4536122" y="6130700"/>
              <a:ext cx="158417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4799403" y="6087631"/>
              <a:ext cx="792088" cy="311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msmeg_1886</a:t>
              </a:r>
              <a:endParaRPr lang="en-GB" sz="800" dirty="0"/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>
              <a:off x="2871986" y="6130700"/>
              <a:ext cx="129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3135269" y="6087631"/>
              <a:ext cx="792088" cy="3111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msmeg_1885</a:t>
              </a:r>
              <a:endParaRPr lang="en-GB" sz="800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492896" y="3279319"/>
              <a:ext cx="4176464" cy="3042338"/>
            </a:xfrm>
            <a:prstGeom prst="rect">
              <a:avLst/>
            </a:prstGeom>
            <a:noFill/>
            <a:ln w="95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4</TotalTime>
  <Words>17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 Jenkins</dc:creator>
  <cp:lastModifiedBy>Brian Robertson</cp:lastModifiedBy>
  <cp:revision>222</cp:revision>
  <dcterms:created xsi:type="dcterms:W3CDTF">2012-07-09T10:39:38Z</dcterms:created>
  <dcterms:modified xsi:type="dcterms:W3CDTF">2013-02-27T17:18:31Z</dcterms:modified>
</cp:coreProperties>
</file>